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8014" autoAdjust="0"/>
    <p:restoredTop sz="82465" autoAdjust="0"/>
  </p:normalViewPr>
  <p:slideViewPr>
    <p:cSldViewPr snapToGrid="0">
      <p:cViewPr varScale="1">
        <p:scale>
          <a:sx n="52" d="100"/>
          <a:sy n="52" d="100"/>
        </p:scale>
        <p:origin x="1156" y="5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atsumi\Downloads\Fig2&#12486;&#12441;&#12540;&#12479;_211124&#12398;&#12467;&#12498;&#12442;&#12540;(&#33258;&#21205;&#22238;&#24489;&#28168;&#12415;)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atsumi\Downloads\Fig2&#12486;&#12441;&#12540;&#12479;_211124&#12398;&#12467;&#12498;&#12442;&#12540;(&#33258;&#21205;&#22238;&#24489;&#28168;&#12415;)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atsumi\Downloads\Fig2&#12486;&#12441;&#12540;&#12479;_211124&#12398;&#12467;&#12498;&#12442;&#12540;(&#33258;&#21205;&#22238;&#24489;&#28168;&#12415;)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atsumi\Downloads\Fig2&#12486;&#12441;&#12540;&#12479;_211124&#12398;&#12467;&#12498;&#12442;&#12540;(&#33258;&#21205;&#22238;&#24489;&#28168;&#12415;)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atsumi\Downloads\Fig2&#12486;&#12441;&#12540;&#12479;_211124&#12398;&#12467;&#12498;&#12442;&#12540;(&#33258;&#21205;&#22238;&#24489;&#28168;&#12415;)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atsumi\Downloads\Fig2&#12486;&#12441;&#12540;&#12479;_211124&#12398;&#12467;&#12498;&#12442;&#12540;(&#33258;&#21205;&#22238;&#24489;&#28168;&#12415;)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atsumi\Downloads\Fig2&#12486;&#12441;&#12540;&#12479;_211124&#12398;&#12467;&#12498;&#12442;&#12540;(&#33258;&#21205;&#22238;&#24489;&#28168;&#12415;)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atsumi\Downloads\Fig2&#12486;&#12441;&#12540;&#12479;_211124&#12398;&#12467;&#12498;&#12442;&#12540;(220312)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Anorexia(220311)'!$F$62</c:f>
              <c:strCache>
                <c:ptCount val="1"/>
                <c:pt idx="0">
                  <c:v>O-desmethyl gefitinib
AUCall (uMh)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7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Pt>
            <c:idx val="11"/>
            <c:marker>
              <c:symbol val="dash"/>
              <c:size val="15"/>
              <c:spPr>
                <a:solidFill>
                  <a:schemeClr val="tx1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8FBA-734C-92BD-FAD3F8FA5FC7}"/>
              </c:ext>
            </c:extLst>
          </c:dPt>
          <c:dPt>
            <c:idx val="17"/>
            <c:marker>
              <c:symbol val="dash"/>
              <c:size val="15"/>
              <c:spPr>
                <a:solidFill>
                  <a:schemeClr val="tx1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8FBA-734C-92BD-FAD3F8FA5FC7}"/>
              </c:ext>
            </c:extLst>
          </c:dPt>
          <c:xVal>
            <c:numRef>
              <c:f>'Anorexia(220311)'!$E$63:$E$91</c:f>
              <c:numCache>
                <c:formatCode>General</c:formatCode>
                <c:ptCount val="29"/>
                <c:pt idx="0">
                  <c:v>0.5</c:v>
                </c:pt>
                <c:pt idx="1">
                  <c:v>0.4</c:v>
                </c:pt>
                <c:pt idx="2">
                  <c:v>0.6</c:v>
                </c:pt>
                <c:pt idx="3">
                  <c:v>0.3</c:v>
                </c:pt>
                <c:pt idx="4">
                  <c:v>0.7</c:v>
                </c:pt>
                <c:pt idx="5">
                  <c:v>1.4</c:v>
                </c:pt>
                <c:pt idx="6">
                  <c:v>1.6</c:v>
                </c:pt>
                <c:pt idx="7">
                  <c:v>0.2</c:v>
                </c:pt>
                <c:pt idx="8">
                  <c:v>0.5</c:v>
                </c:pt>
                <c:pt idx="9">
                  <c:v>0.7</c:v>
                </c:pt>
                <c:pt idx="10">
                  <c:v>0.3</c:v>
                </c:pt>
                <c:pt idx="11">
                  <c:v>0.5</c:v>
                </c:pt>
                <c:pt idx="12">
                  <c:v>0.8</c:v>
                </c:pt>
                <c:pt idx="13">
                  <c:v>0.5</c:v>
                </c:pt>
                <c:pt idx="14">
                  <c:v>0.5</c:v>
                </c:pt>
                <c:pt idx="15">
                  <c:v>0.5</c:v>
                </c:pt>
                <c:pt idx="16">
                  <c:v>0.5</c:v>
                </c:pt>
                <c:pt idx="17">
                  <c:v>1.5</c:v>
                </c:pt>
                <c:pt idx="18">
                  <c:v>1.5</c:v>
                </c:pt>
                <c:pt idx="19">
                  <c:v>1.5</c:v>
                </c:pt>
              </c:numCache>
            </c:numRef>
          </c:xVal>
          <c:yVal>
            <c:numRef>
              <c:f>'Anorexia(220311)'!$F$63:$F$91</c:f>
              <c:numCache>
                <c:formatCode>General</c:formatCode>
                <c:ptCount val="29"/>
                <c:pt idx="0">
                  <c:v>0</c:v>
                </c:pt>
                <c:pt idx="1">
                  <c:v>1.9440318999999999</c:v>
                </c:pt>
                <c:pt idx="2">
                  <c:v>2.7074395999999998</c:v>
                </c:pt>
                <c:pt idx="3">
                  <c:v>2.9317391000000002</c:v>
                </c:pt>
                <c:pt idx="4">
                  <c:v>3.0229556999999998</c:v>
                </c:pt>
                <c:pt idx="5">
                  <c:v>3.6360785</c:v>
                </c:pt>
                <c:pt idx="6">
                  <c:v>4.3649503000000003</c:v>
                </c:pt>
                <c:pt idx="7">
                  <c:v>5.3829536999999998</c:v>
                </c:pt>
                <c:pt idx="8">
                  <c:v>5.5368442</c:v>
                </c:pt>
                <c:pt idx="9">
                  <c:v>5.6156334000000001</c:v>
                </c:pt>
                <c:pt idx="10">
                  <c:v>6.071269</c:v>
                </c:pt>
                <c:pt idx="11">
                  <c:v>6.3520000000000003</c:v>
                </c:pt>
                <c:pt idx="12">
                  <c:v>6.7926621999999997</c:v>
                </c:pt>
                <c:pt idx="13">
                  <c:v>7.8335610999999998</c:v>
                </c:pt>
                <c:pt idx="14">
                  <c:v>11.648548999999999</c:v>
                </c:pt>
                <c:pt idx="15">
                  <c:v>13.47207</c:v>
                </c:pt>
                <c:pt idx="16">
                  <c:v>15.967069</c:v>
                </c:pt>
                <c:pt idx="17">
                  <c:v>25.29</c:v>
                </c:pt>
                <c:pt idx="18">
                  <c:v>36.136633000000003</c:v>
                </c:pt>
                <c:pt idx="19">
                  <c:v>57.0381489999999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8FBA-734C-92BD-FAD3F8FA5FC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73049904"/>
        <c:axId val="972479648"/>
      </c:scatterChart>
      <c:valAx>
        <c:axId val="973049904"/>
        <c:scaling>
          <c:orientation val="minMax"/>
          <c:max val="2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one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72479648"/>
        <c:crosses val="autoZero"/>
        <c:crossBetween val="midCat"/>
      </c:valAx>
      <c:valAx>
        <c:axId val="972479648"/>
        <c:scaling>
          <c:orientation val="minMax"/>
          <c:max val="6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in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973049904"/>
        <c:crosses val="autoZero"/>
        <c:crossBetween val="midCat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Diarreah(220311)'!$F$33</c:f>
              <c:strCache>
                <c:ptCount val="1"/>
                <c:pt idx="0">
                  <c:v>O-desmethyl gefitinib
AUCall (uMh)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7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Pt>
            <c:idx val="27"/>
            <c:marker>
              <c:symbol val="dash"/>
              <c:size val="15"/>
              <c:spPr>
                <a:solidFill>
                  <a:schemeClr val="tx1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77FF-9140-960C-8A6F7F163A9A}"/>
              </c:ext>
            </c:extLst>
          </c:dPt>
          <c:dPt>
            <c:idx val="28"/>
            <c:marker>
              <c:symbol val="dash"/>
              <c:size val="15"/>
              <c:spPr>
                <a:solidFill>
                  <a:schemeClr val="tx1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77FF-9140-960C-8A6F7F163A9A}"/>
              </c:ext>
            </c:extLst>
          </c:dPt>
          <c:xVal>
            <c:numRef>
              <c:f>'Diarreah(220311)'!$E$34:$E$62</c:f>
              <c:numCache>
                <c:formatCode>General</c:formatCode>
                <c:ptCount val="29"/>
                <c:pt idx="0">
                  <c:v>1.5</c:v>
                </c:pt>
                <c:pt idx="1">
                  <c:v>0.5</c:v>
                </c:pt>
                <c:pt idx="2">
                  <c:v>1.5</c:v>
                </c:pt>
                <c:pt idx="4">
                  <c:v>0.5</c:v>
                </c:pt>
                <c:pt idx="5">
                  <c:v>1.3</c:v>
                </c:pt>
                <c:pt idx="7">
                  <c:v>1.5</c:v>
                </c:pt>
                <c:pt idx="11">
                  <c:v>0.5</c:v>
                </c:pt>
                <c:pt idx="12">
                  <c:v>1.7</c:v>
                </c:pt>
                <c:pt idx="14">
                  <c:v>0.5</c:v>
                </c:pt>
                <c:pt idx="15">
                  <c:v>1.5</c:v>
                </c:pt>
                <c:pt idx="17">
                  <c:v>1.5</c:v>
                </c:pt>
                <c:pt idx="18">
                  <c:v>1.6</c:v>
                </c:pt>
                <c:pt idx="20">
                  <c:v>0.35</c:v>
                </c:pt>
                <c:pt idx="21">
                  <c:v>0.6</c:v>
                </c:pt>
                <c:pt idx="22">
                  <c:v>0.65</c:v>
                </c:pt>
                <c:pt idx="23">
                  <c:v>0.4</c:v>
                </c:pt>
                <c:pt idx="25">
                  <c:v>0.5</c:v>
                </c:pt>
                <c:pt idx="26">
                  <c:v>1.4</c:v>
                </c:pt>
                <c:pt idx="27">
                  <c:v>0.5</c:v>
                </c:pt>
                <c:pt idx="28">
                  <c:v>1.5</c:v>
                </c:pt>
              </c:numCache>
            </c:numRef>
          </c:xVal>
          <c:yVal>
            <c:numRef>
              <c:f>'Diarreah(220311)'!$F$34:$F$62</c:f>
              <c:numCache>
                <c:formatCode>General</c:formatCode>
                <c:ptCount val="29"/>
                <c:pt idx="0">
                  <c:v>36.136633000000003</c:v>
                </c:pt>
                <c:pt idx="1">
                  <c:v>7.8335610999999998</c:v>
                </c:pt>
                <c:pt idx="2">
                  <c:v>57.038148999999997</c:v>
                </c:pt>
                <c:pt idx="4">
                  <c:v>13.47207</c:v>
                </c:pt>
                <c:pt idx="5">
                  <c:v>5.5368442</c:v>
                </c:pt>
                <c:pt idx="7">
                  <c:v>11.648548999999999</c:v>
                </c:pt>
                <c:pt idx="11">
                  <c:v>2.7074395999999998</c:v>
                </c:pt>
                <c:pt idx="12">
                  <c:v>6.7926621999999997</c:v>
                </c:pt>
                <c:pt idx="14">
                  <c:v>15.967069</c:v>
                </c:pt>
                <c:pt idx="15">
                  <c:v>5.6156334000000001</c:v>
                </c:pt>
                <c:pt idx="17">
                  <c:v>3.0229556999999998</c:v>
                </c:pt>
                <c:pt idx="18">
                  <c:v>4.3649503000000003</c:v>
                </c:pt>
                <c:pt idx="20">
                  <c:v>5.3829536999999998</c:v>
                </c:pt>
                <c:pt idx="21">
                  <c:v>2.9317391000000002</c:v>
                </c:pt>
                <c:pt idx="22">
                  <c:v>6.071269</c:v>
                </c:pt>
                <c:pt idx="23">
                  <c:v>1.9440318999999999</c:v>
                </c:pt>
                <c:pt idx="25">
                  <c:v>0</c:v>
                </c:pt>
                <c:pt idx="26">
                  <c:v>3.6360785</c:v>
                </c:pt>
                <c:pt idx="27">
                  <c:v>6.26</c:v>
                </c:pt>
                <c:pt idx="28">
                  <c:v>14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77FF-9140-960C-8A6F7F163A9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73049904"/>
        <c:axId val="972479648"/>
      </c:scatterChart>
      <c:valAx>
        <c:axId val="973049904"/>
        <c:scaling>
          <c:orientation val="minMax"/>
          <c:max val="2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one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72479648"/>
        <c:crosses val="autoZero"/>
        <c:crossBetween val="midCat"/>
      </c:valAx>
      <c:valAx>
        <c:axId val="972479648"/>
        <c:scaling>
          <c:orientation val="minMax"/>
          <c:max val="6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in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973049904"/>
        <c:crosses val="autoZero"/>
        <c:crossBetween val="midCat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Rash(220311)'!$F$33</c:f>
              <c:strCache>
                <c:ptCount val="1"/>
                <c:pt idx="0">
                  <c:v>O-desmethyl gefitinib
AUCall (uMh)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7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Pt>
            <c:idx val="27"/>
            <c:marker>
              <c:symbol val="dash"/>
              <c:size val="15"/>
              <c:spPr>
                <a:solidFill>
                  <a:schemeClr val="tx1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9B3A-294E-809F-4F75415BE24D}"/>
              </c:ext>
            </c:extLst>
          </c:dPt>
          <c:dPt>
            <c:idx val="28"/>
            <c:marker>
              <c:symbol val="dash"/>
              <c:size val="15"/>
              <c:spPr>
                <a:solidFill>
                  <a:schemeClr val="tx1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9B3A-294E-809F-4F75415BE24D}"/>
              </c:ext>
            </c:extLst>
          </c:dPt>
          <c:xVal>
            <c:numRef>
              <c:f>'Rash(220311)'!$E$34:$E$62</c:f>
              <c:numCache>
                <c:formatCode>General</c:formatCode>
                <c:ptCount val="29"/>
                <c:pt idx="0">
                  <c:v>0.5</c:v>
                </c:pt>
                <c:pt idx="1">
                  <c:v>0.5</c:v>
                </c:pt>
                <c:pt idx="2">
                  <c:v>1.5</c:v>
                </c:pt>
                <c:pt idx="4">
                  <c:v>0.55000000000000004</c:v>
                </c:pt>
                <c:pt idx="5">
                  <c:v>0.5</c:v>
                </c:pt>
                <c:pt idx="7">
                  <c:v>0.45</c:v>
                </c:pt>
                <c:pt idx="11">
                  <c:v>0.75</c:v>
                </c:pt>
                <c:pt idx="12">
                  <c:v>1.45</c:v>
                </c:pt>
                <c:pt idx="14">
                  <c:v>0.5</c:v>
                </c:pt>
                <c:pt idx="15">
                  <c:v>1.55</c:v>
                </c:pt>
                <c:pt idx="17">
                  <c:v>1.5</c:v>
                </c:pt>
                <c:pt idx="18">
                  <c:v>0.3</c:v>
                </c:pt>
                <c:pt idx="20">
                  <c:v>0.65</c:v>
                </c:pt>
                <c:pt idx="21">
                  <c:v>0.6</c:v>
                </c:pt>
                <c:pt idx="22">
                  <c:v>0.4</c:v>
                </c:pt>
                <c:pt idx="23">
                  <c:v>0.5</c:v>
                </c:pt>
                <c:pt idx="25">
                  <c:v>1.5</c:v>
                </c:pt>
                <c:pt idx="26">
                  <c:v>0.4</c:v>
                </c:pt>
                <c:pt idx="27">
                  <c:v>0.5</c:v>
                </c:pt>
                <c:pt idx="28">
                  <c:v>1.5</c:v>
                </c:pt>
              </c:numCache>
            </c:numRef>
          </c:xVal>
          <c:yVal>
            <c:numRef>
              <c:f>'Rash(220311)'!$F$34:$F$62</c:f>
              <c:numCache>
                <c:formatCode>General</c:formatCode>
                <c:ptCount val="29"/>
                <c:pt idx="0">
                  <c:v>36.136633000000003</c:v>
                </c:pt>
                <c:pt idx="1">
                  <c:v>7.8335610999999998</c:v>
                </c:pt>
                <c:pt idx="2">
                  <c:v>57.038148999999997</c:v>
                </c:pt>
                <c:pt idx="4">
                  <c:v>13.47207</c:v>
                </c:pt>
                <c:pt idx="5">
                  <c:v>5.5368442</c:v>
                </c:pt>
                <c:pt idx="7">
                  <c:v>11.648548999999999</c:v>
                </c:pt>
                <c:pt idx="11">
                  <c:v>2.7074395999999998</c:v>
                </c:pt>
                <c:pt idx="12">
                  <c:v>6.7926621999999997</c:v>
                </c:pt>
                <c:pt idx="14">
                  <c:v>15.967069</c:v>
                </c:pt>
                <c:pt idx="15">
                  <c:v>5.6156334000000001</c:v>
                </c:pt>
                <c:pt idx="17">
                  <c:v>3.0229556999999998</c:v>
                </c:pt>
                <c:pt idx="18">
                  <c:v>4.3649503000000003</c:v>
                </c:pt>
                <c:pt idx="20">
                  <c:v>5.3829536999999998</c:v>
                </c:pt>
                <c:pt idx="21">
                  <c:v>2.9317391000000002</c:v>
                </c:pt>
                <c:pt idx="22">
                  <c:v>6.071269</c:v>
                </c:pt>
                <c:pt idx="23">
                  <c:v>1.9440318999999999</c:v>
                </c:pt>
                <c:pt idx="25">
                  <c:v>0</c:v>
                </c:pt>
                <c:pt idx="26">
                  <c:v>3.6360785</c:v>
                </c:pt>
                <c:pt idx="27">
                  <c:v>9.0500000000000007</c:v>
                </c:pt>
                <c:pt idx="28">
                  <c:v>14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9B3A-294E-809F-4F75415BE24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73049904"/>
        <c:axId val="972479648"/>
      </c:scatterChart>
      <c:valAx>
        <c:axId val="973049904"/>
        <c:scaling>
          <c:orientation val="minMax"/>
          <c:max val="2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one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72479648"/>
        <c:crosses val="autoZero"/>
        <c:crossBetween val="midCat"/>
      </c:valAx>
      <c:valAx>
        <c:axId val="972479648"/>
        <c:scaling>
          <c:orientation val="minMax"/>
          <c:max val="6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in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973049904"/>
        <c:crosses val="autoZero"/>
        <c:crossBetween val="midCat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Malaise(220311) (2)'!$F$33</c:f>
              <c:strCache>
                <c:ptCount val="1"/>
                <c:pt idx="0">
                  <c:v>O-desmethyl gefitinib
AUCall (uMh)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7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Pt>
            <c:idx val="27"/>
            <c:marker>
              <c:symbol val="dash"/>
              <c:size val="15"/>
              <c:spPr>
                <a:solidFill>
                  <a:schemeClr val="tx1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824F-1241-8DAB-012AE355FBFD}"/>
              </c:ext>
            </c:extLst>
          </c:dPt>
          <c:dPt>
            <c:idx val="28"/>
            <c:marker>
              <c:symbol val="dash"/>
              <c:size val="15"/>
              <c:spPr>
                <a:solidFill>
                  <a:schemeClr val="tx1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824F-1241-8DAB-012AE355FBFD}"/>
              </c:ext>
            </c:extLst>
          </c:dPt>
          <c:xVal>
            <c:numRef>
              <c:f>'Malaise(220311) (2)'!$E$34:$E$62</c:f>
              <c:numCache>
                <c:formatCode>General</c:formatCode>
                <c:ptCount val="29"/>
                <c:pt idx="0">
                  <c:v>1.5</c:v>
                </c:pt>
                <c:pt idx="1">
                  <c:v>0.5</c:v>
                </c:pt>
                <c:pt idx="2">
                  <c:v>1.5</c:v>
                </c:pt>
                <c:pt idx="4">
                  <c:v>0.55000000000000004</c:v>
                </c:pt>
                <c:pt idx="5">
                  <c:v>0.8</c:v>
                </c:pt>
                <c:pt idx="7">
                  <c:v>0.45</c:v>
                </c:pt>
                <c:pt idx="11">
                  <c:v>0.4</c:v>
                </c:pt>
                <c:pt idx="12">
                  <c:v>1.5</c:v>
                </c:pt>
                <c:pt idx="14">
                  <c:v>0.5</c:v>
                </c:pt>
                <c:pt idx="15">
                  <c:v>0.7</c:v>
                </c:pt>
                <c:pt idx="17">
                  <c:v>0.6</c:v>
                </c:pt>
                <c:pt idx="18">
                  <c:v>1.5</c:v>
                </c:pt>
                <c:pt idx="20">
                  <c:v>0.2</c:v>
                </c:pt>
                <c:pt idx="21">
                  <c:v>0.3</c:v>
                </c:pt>
                <c:pt idx="22">
                  <c:v>0.3</c:v>
                </c:pt>
                <c:pt idx="23">
                  <c:v>0.5</c:v>
                </c:pt>
                <c:pt idx="25">
                  <c:v>0.5</c:v>
                </c:pt>
                <c:pt idx="26">
                  <c:v>0.7</c:v>
                </c:pt>
                <c:pt idx="27">
                  <c:v>0.5</c:v>
                </c:pt>
                <c:pt idx="28">
                  <c:v>1.5</c:v>
                </c:pt>
              </c:numCache>
            </c:numRef>
          </c:xVal>
          <c:yVal>
            <c:numRef>
              <c:f>'Malaise(220311) (2)'!$F$34:$F$62</c:f>
              <c:numCache>
                <c:formatCode>General</c:formatCode>
                <c:ptCount val="29"/>
                <c:pt idx="0">
                  <c:v>36.136633000000003</c:v>
                </c:pt>
                <c:pt idx="1">
                  <c:v>7.8335610999999998</c:v>
                </c:pt>
                <c:pt idx="2">
                  <c:v>57.038148999999997</c:v>
                </c:pt>
                <c:pt idx="4">
                  <c:v>13.47207</c:v>
                </c:pt>
                <c:pt idx="5">
                  <c:v>5.5368442</c:v>
                </c:pt>
                <c:pt idx="7">
                  <c:v>11.648548999999999</c:v>
                </c:pt>
                <c:pt idx="11">
                  <c:v>2.7074395999999998</c:v>
                </c:pt>
                <c:pt idx="12">
                  <c:v>6.7926621999999997</c:v>
                </c:pt>
                <c:pt idx="14">
                  <c:v>15.967069</c:v>
                </c:pt>
                <c:pt idx="15">
                  <c:v>5.6156334000000001</c:v>
                </c:pt>
                <c:pt idx="17">
                  <c:v>3.0229556999999998</c:v>
                </c:pt>
                <c:pt idx="18">
                  <c:v>4.3649503000000003</c:v>
                </c:pt>
                <c:pt idx="20">
                  <c:v>5.3829536999999998</c:v>
                </c:pt>
                <c:pt idx="21">
                  <c:v>2.9317391000000002</c:v>
                </c:pt>
                <c:pt idx="22">
                  <c:v>6.071269</c:v>
                </c:pt>
                <c:pt idx="23">
                  <c:v>1.9440318999999999</c:v>
                </c:pt>
                <c:pt idx="25">
                  <c:v>0</c:v>
                </c:pt>
                <c:pt idx="26">
                  <c:v>3.6360785</c:v>
                </c:pt>
                <c:pt idx="27">
                  <c:v>6.1260000000000003</c:v>
                </c:pt>
                <c:pt idx="28">
                  <c:v>26.0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824F-1241-8DAB-012AE355FBF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73049904"/>
        <c:axId val="972479648"/>
      </c:scatterChart>
      <c:valAx>
        <c:axId val="973049904"/>
        <c:scaling>
          <c:orientation val="minMax"/>
          <c:max val="2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one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72479648"/>
        <c:crosses val="autoZero"/>
        <c:crossBetween val="midCat"/>
      </c:valAx>
      <c:valAx>
        <c:axId val="972479648"/>
        <c:scaling>
          <c:orientation val="minMax"/>
          <c:max val="6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in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973049904"/>
        <c:crosses val="autoZero"/>
        <c:crossBetween val="midCat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Anorexia(220311)'!$F$30</c:f>
              <c:strCache>
                <c:ptCount val="1"/>
                <c:pt idx="0">
                  <c:v>gefitinib
AUCall (uMh)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7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Pt>
            <c:idx val="27"/>
            <c:marker>
              <c:symbol val="dash"/>
              <c:size val="15"/>
              <c:spPr>
                <a:solidFill>
                  <a:schemeClr val="tx1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A56C-CE4C-A6F8-79442BEE56F7}"/>
              </c:ext>
            </c:extLst>
          </c:dPt>
          <c:dPt>
            <c:idx val="28"/>
            <c:marker>
              <c:symbol val="dash"/>
              <c:size val="15"/>
              <c:spPr>
                <a:solidFill>
                  <a:schemeClr val="tx1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A56C-CE4C-A6F8-79442BEE56F7}"/>
              </c:ext>
            </c:extLst>
          </c:dPt>
          <c:xVal>
            <c:numRef>
              <c:f>'Anorexia(220311)'!$E$31:$E$59</c:f>
              <c:numCache>
                <c:formatCode>General</c:formatCode>
                <c:ptCount val="29"/>
                <c:pt idx="0">
                  <c:v>1.5</c:v>
                </c:pt>
                <c:pt idx="1">
                  <c:v>0.5</c:v>
                </c:pt>
                <c:pt idx="2">
                  <c:v>1.5</c:v>
                </c:pt>
                <c:pt idx="4">
                  <c:v>0.5</c:v>
                </c:pt>
                <c:pt idx="5">
                  <c:v>0.5</c:v>
                </c:pt>
                <c:pt idx="7">
                  <c:v>0.5</c:v>
                </c:pt>
                <c:pt idx="11">
                  <c:v>0.55000000000000004</c:v>
                </c:pt>
                <c:pt idx="12">
                  <c:v>0.5</c:v>
                </c:pt>
                <c:pt idx="14">
                  <c:v>0.45</c:v>
                </c:pt>
                <c:pt idx="15">
                  <c:v>0.5</c:v>
                </c:pt>
                <c:pt idx="17">
                  <c:v>0.6</c:v>
                </c:pt>
                <c:pt idx="18">
                  <c:v>1.5</c:v>
                </c:pt>
                <c:pt idx="20">
                  <c:v>0.4</c:v>
                </c:pt>
                <c:pt idx="21">
                  <c:v>0.6</c:v>
                </c:pt>
                <c:pt idx="22">
                  <c:v>0.4</c:v>
                </c:pt>
                <c:pt idx="23">
                  <c:v>0.45</c:v>
                </c:pt>
                <c:pt idx="25">
                  <c:v>0.55000000000000004</c:v>
                </c:pt>
                <c:pt idx="26">
                  <c:v>1.5</c:v>
                </c:pt>
                <c:pt idx="27">
                  <c:v>0.5</c:v>
                </c:pt>
                <c:pt idx="28">
                  <c:v>1.5</c:v>
                </c:pt>
              </c:numCache>
            </c:numRef>
          </c:xVal>
          <c:yVal>
            <c:numRef>
              <c:f>'Anorexia(220311)'!$F$31:$F$59</c:f>
              <c:numCache>
                <c:formatCode>General</c:formatCode>
                <c:ptCount val="29"/>
                <c:pt idx="0">
                  <c:v>6.1482070000000002</c:v>
                </c:pt>
                <c:pt idx="1">
                  <c:v>5.9167594000000001</c:v>
                </c:pt>
                <c:pt idx="2">
                  <c:v>5.1046490999999996</c:v>
                </c:pt>
                <c:pt idx="4">
                  <c:v>6.5676436000000002</c:v>
                </c:pt>
                <c:pt idx="5">
                  <c:v>8.6831391999999994</c:v>
                </c:pt>
                <c:pt idx="7">
                  <c:v>4.8929938999999996</c:v>
                </c:pt>
                <c:pt idx="11">
                  <c:v>14.278466999999999</c:v>
                </c:pt>
                <c:pt idx="12">
                  <c:v>7.5507549999999997</c:v>
                </c:pt>
                <c:pt idx="14">
                  <c:v>14.598188</c:v>
                </c:pt>
                <c:pt idx="15">
                  <c:v>10.663679</c:v>
                </c:pt>
                <c:pt idx="17">
                  <c:v>10.508322</c:v>
                </c:pt>
                <c:pt idx="18">
                  <c:v>15.342646999999999</c:v>
                </c:pt>
                <c:pt idx="20">
                  <c:v>6.8755667000000003</c:v>
                </c:pt>
                <c:pt idx="21">
                  <c:v>6.4035595000000001</c:v>
                </c:pt>
                <c:pt idx="22">
                  <c:v>10.621884</c:v>
                </c:pt>
                <c:pt idx="23">
                  <c:v>12.06644</c:v>
                </c:pt>
                <c:pt idx="25">
                  <c:v>12.173482</c:v>
                </c:pt>
                <c:pt idx="26">
                  <c:v>12.377668999999999</c:v>
                </c:pt>
                <c:pt idx="27">
                  <c:v>9.4143000000000008</c:v>
                </c:pt>
                <c:pt idx="28">
                  <c:v>9.74300000000000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A56C-CE4C-A6F8-79442BEE56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73049904"/>
        <c:axId val="972479648"/>
      </c:scatterChart>
      <c:valAx>
        <c:axId val="973049904"/>
        <c:scaling>
          <c:orientation val="minMax"/>
          <c:max val="2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one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72479648"/>
        <c:crosses val="autoZero"/>
        <c:crossBetween val="midCat"/>
      </c:valAx>
      <c:valAx>
        <c:axId val="972479648"/>
        <c:scaling>
          <c:orientation val="minMax"/>
          <c:max val="2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in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973049904"/>
        <c:crosses val="autoZero"/>
        <c:crossBetween val="midCat"/>
        <c:majorUnit val="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Diarreah(220311)'!$F$1</c:f>
              <c:strCache>
                <c:ptCount val="1"/>
                <c:pt idx="0">
                  <c:v>gefitinib
AUCall (uMh)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7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Pt>
            <c:idx val="27"/>
            <c:marker>
              <c:symbol val="dash"/>
              <c:size val="15"/>
              <c:spPr>
                <a:solidFill>
                  <a:schemeClr val="tx1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D2B1-3341-BBD1-751C642DA1BF}"/>
              </c:ext>
            </c:extLst>
          </c:dPt>
          <c:dPt>
            <c:idx val="28"/>
            <c:marker>
              <c:symbol val="dash"/>
              <c:size val="15"/>
              <c:spPr>
                <a:solidFill>
                  <a:schemeClr val="tx1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D2B1-3341-BBD1-751C642DA1BF}"/>
              </c:ext>
            </c:extLst>
          </c:dPt>
          <c:xVal>
            <c:numRef>
              <c:f>'Diarreah(220311)'!$E$2:$E$30</c:f>
              <c:numCache>
                <c:formatCode>General</c:formatCode>
                <c:ptCount val="29"/>
                <c:pt idx="0">
                  <c:v>1.5</c:v>
                </c:pt>
                <c:pt idx="1">
                  <c:v>0.5</c:v>
                </c:pt>
                <c:pt idx="2">
                  <c:v>1.55</c:v>
                </c:pt>
                <c:pt idx="4">
                  <c:v>0.4</c:v>
                </c:pt>
                <c:pt idx="5">
                  <c:v>1.5</c:v>
                </c:pt>
                <c:pt idx="7">
                  <c:v>1.45</c:v>
                </c:pt>
                <c:pt idx="11">
                  <c:v>0.45</c:v>
                </c:pt>
                <c:pt idx="12">
                  <c:v>1.5</c:v>
                </c:pt>
                <c:pt idx="14">
                  <c:v>0.55000000000000004</c:v>
                </c:pt>
                <c:pt idx="15">
                  <c:v>1.55</c:v>
                </c:pt>
                <c:pt idx="17">
                  <c:v>1.45</c:v>
                </c:pt>
                <c:pt idx="18">
                  <c:v>1.5</c:v>
                </c:pt>
                <c:pt idx="20">
                  <c:v>0.5</c:v>
                </c:pt>
                <c:pt idx="21">
                  <c:v>0.6</c:v>
                </c:pt>
                <c:pt idx="22">
                  <c:v>0.5</c:v>
                </c:pt>
                <c:pt idx="23">
                  <c:v>0.45</c:v>
                </c:pt>
                <c:pt idx="25">
                  <c:v>0.55000000000000004</c:v>
                </c:pt>
                <c:pt idx="26">
                  <c:v>1.5</c:v>
                </c:pt>
                <c:pt idx="27">
                  <c:v>1.5</c:v>
                </c:pt>
                <c:pt idx="28">
                  <c:v>0.5</c:v>
                </c:pt>
              </c:numCache>
            </c:numRef>
          </c:xVal>
          <c:yVal>
            <c:numRef>
              <c:f>'Diarreah(220311)'!$F$2:$F$30</c:f>
              <c:numCache>
                <c:formatCode>General</c:formatCode>
                <c:ptCount val="29"/>
                <c:pt idx="0">
                  <c:v>6.1482070000000002</c:v>
                </c:pt>
                <c:pt idx="1">
                  <c:v>5.9167594000000001</c:v>
                </c:pt>
                <c:pt idx="2">
                  <c:v>5.1046490999999996</c:v>
                </c:pt>
                <c:pt idx="4">
                  <c:v>6.5676436000000002</c:v>
                </c:pt>
                <c:pt idx="5">
                  <c:v>8.6831391999999994</c:v>
                </c:pt>
                <c:pt idx="7">
                  <c:v>4.8929938999999996</c:v>
                </c:pt>
                <c:pt idx="11">
                  <c:v>14.278466999999999</c:v>
                </c:pt>
                <c:pt idx="12">
                  <c:v>7.5507549999999997</c:v>
                </c:pt>
                <c:pt idx="14">
                  <c:v>14.598188</c:v>
                </c:pt>
                <c:pt idx="15">
                  <c:v>10.663679</c:v>
                </c:pt>
                <c:pt idx="17">
                  <c:v>10.508322</c:v>
                </c:pt>
                <c:pt idx="18">
                  <c:v>15.342646999999999</c:v>
                </c:pt>
                <c:pt idx="20">
                  <c:v>6.8755667000000003</c:v>
                </c:pt>
                <c:pt idx="21">
                  <c:v>6.4035595000000001</c:v>
                </c:pt>
                <c:pt idx="22">
                  <c:v>10.621884</c:v>
                </c:pt>
                <c:pt idx="23">
                  <c:v>12.06644</c:v>
                </c:pt>
                <c:pt idx="25">
                  <c:v>12.173482</c:v>
                </c:pt>
                <c:pt idx="26">
                  <c:v>12.377668999999999</c:v>
                </c:pt>
                <c:pt idx="27">
                  <c:v>9.0299999999999994</c:v>
                </c:pt>
                <c:pt idx="28">
                  <c:v>9.9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C39B-1848-AC8C-D3E60348DA0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73049904"/>
        <c:axId val="972479648"/>
      </c:scatterChart>
      <c:valAx>
        <c:axId val="973049904"/>
        <c:scaling>
          <c:orientation val="minMax"/>
          <c:max val="2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one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72479648"/>
        <c:crosses val="autoZero"/>
        <c:crossBetween val="midCat"/>
      </c:valAx>
      <c:valAx>
        <c:axId val="972479648"/>
        <c:scaling>
          <c:orientation val="minMax"/>
          <c:max val="2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in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973049904"/>
        <c:crosses val="autoZero"/>
        <c:crossBetween val="midCat"/>
        <c:majorUnit val="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Malaise(220311) (2)'!$F$1</c:f>
              <c:strCache>
                <c:ptCount val="1"/>
                <c:pt idx="0">
                  <c:v>gefitinib
AUCall (uMh)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7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Pt>
            <c:idx val="27"/>
            <c:marker>
              <c:symbol val="dash"/>
              <c:size val="15"/>
              <c:spPr>
                <a:solidFill>
                  <a:schemeClr val="tx1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97B5-9042-96E8-4221ABA2C241}"/>
              </c:ext>
            </c:extLst>
          </c:dPt>
          <c:dPt>
            <c:idx val="28"/>
            <c:marker>
              <c:symbol val="dash"/>
              <c:size val="15"/>
              <c:spPr>
                <a:solidFill>
                  <a:schemeClr val="tx1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97B5-9042-96E8-4221ABA2C241}"/>
              </c:ext>
            </c:extLst>
          </c:dPt>
          <c:xVal>
            <c:numRef>
              <c:f>'Malaise(220311) (2)'!$E$2:$E$30</c:f>
              <c:numCache>
                <c:formatCode>General</c:formatCode>
                <c:ptCount val="29"/>
                <c:pt idx="0">
                  <c:v>1.5</c:v>
                </c:pt>
                <c:pt idx="1">
                  <c:v>0.45</c:v>
                </c:pt>
                <c:pt idx="2">
                  <c:v>1.5</c:v>
                </c:pt>
                <c:pt idx="4">
                  <c:v>0.65</c:v>
                </c:pt>
                <c:pt idx="5">
                  <c:v>0.5</c:v>
                </c:pt>
                <c:pt idx="7">
                  <c:v>0.5</c:v>
                </c:pt>
                <c:pt idx="11">
                  <c:v>0.45</c:v>
                </c:pt>
                <c:pt idx="12">
                  <c:v>1.5</c:v>
                </c:pt>
                <c:pt idx="14">
                  <c:v>0.55000000000000004</c:v>
                </c:pt>
                <c:pt idx="15">
                  <c:v>0.6</c:v>
                </c:pt>
                <c:pt idx="17">
                  <c:v>0.4</c:v>
                </c:pt>
                <c:pt idx="18">
                  <c:v>1.5</c:v>
                </c:pt>
                <c:pt idx="20">
                  <c:v>0.55000000000000004</c:v>
                </c:pt>
                <c:pt idx="21">
                  <c:v>0.35</c:v>
                </c:pt>
                <c:pt idx="22">
                  <c:v>0.5</c:v>
                </c:pt>
                <c:pt idx="23">
                  <c:v>0.4</c:v>
                </c:pt>
                <c:pt idx="25">
                  <c:v>0.5</c:v>
                </c:pt>
                <c:pt idx="26">
                  <c:v>0.6</c:v>
                </c:pt>
                <c:pt idx="27">
                  <c:v>1.5</c:v>
                </c:pt>
                <c:pt idx="28">
                  <c:v>0.5</c:v>
                </c:pt>
              </c:numCache>
            </c:numRef>
          </c:xVal>
          <c:yVal>
            <c:numRef>
              <c:f>'Malaise(220311) (2)'!$F$2:$F$30</c:f>
              <c:numCache>
                <c:formatCode>General</c:formatCode>
                <c:ptCount val="29"/>
                <c:pt idx="0">
                  <c:v>6.1482070000000002</c:v>
                </c:pt>
                <c:pt idx="1">
                  <c:v>5.9167594000000001</c:v>
                </c:pt>
                <c:pt idx="2">
                  <c:v>5.1046490999999996</c:v>
                </c:pt>
                <c:pt idx="4">
                  <c:v>6.5676436000000002</c:v>
                </c:pt>
                <c:pt idx="5">
                  <c:v>8.6831391999999994</c:v>
                </c:pt>
                <c:pt idx="7">
                  <c:v>4.8929938999999996</c:v>
                </c:pt>
                <c:pt idx="11">
                  <c:v>14.278466999999999</c:v>
                </c:pt>
                <c:pt idx="12">
                  <c:v>7.5507549999999997</c:v>
                </c:pt>
                <c:pt idx="14">
                  <c:v>14.598188</c:v>
                </c:pt>
                <c:pt idx="15">
                  <c:v>10.663679</c:v>
                </c:pt>
                <c:pt idx="17">
                  <c:v>10.508322</c:v>
                </c:pt>
                <c:pt idx="18">
                  <c:v>15.342646999999999</c:v>
                </c:pt>
                <c:pt idx="20">
                  <c:v>6.8755667000000003</c:v>
                </c:pt>
                <c:pt idx="21">
                  <c:v>6.4035595000000001</c:v>
                </c:pt>
                <c:pt idx="22">
                  <c:v>10.621884</c:v>
                </c:pt>
                <c:pt idx="23">
                  <c:v>12.06644</c:v>
                </c:pt>
                <c:pt idx="25">
                  <c:v>12.173482</c:v>
                </c:pt>
                <c:pt idx="26">
                  <c:v>12.377668999999999</c:v>
                </c:pt>
                <c:pt idx="27">
                  <c:v>8.5359999999999996</c:v>
                </c:pt>
                <c:pt idx="28">
                  <c:v>9.75900000000000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97B5-9042-96E8-4221ABA2C2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73049904"/>
        <c:axId val="972479648"/>
      </c:scatterChart>
      <c:valAx>
        <c:axId val="973049904"/>
        <c:scaling>
          <c:orientation val="minMax"/>
          <c:max val="2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one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72479648"/>
        <c:crosses val="autoZero"/>
        <c:crossBetween val="midCat"/>
      </c:valAx>
      <c:valAx>
        <c:axId val="972479648"/>
        <c:scaling>
          <c:orientation val="minMax"/>
          <c:max val="2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in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973049904"/>
        <c:crosses val="autoZero"/>
        <c:crossBetween val="midCat"/>
        <c:majorUnit val="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Rash(220311)'!$F$1</c:f>
              <c:strCache>
                <c:ptCount val="1"/>
                <c:pt idx="0">
                  <c:v>gefitinib
AUCall (uMh)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7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Pt>
            <c:idx val="18"/>
            <c:marker>
              <c:symbol val="dash"/>
              <c:size val="15"/>
              <c:spPr>
                <a:solidFill>
                  <a:schemeClr val="tx1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52D9-2343-9E00-856A5A5F5C83}"/>
              </c:ext>
            </c:extLst>
          </c:dPt>
          <c:dPt>
            <c:idx val="19"/>
            <c:marker>
              <c:symbol val="dash"/>
              <c:size val="15"/>
              <c:spPr>
                <a:solidFill>
                  <a:schemeClr val="tx1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52D9-2343-9E00-856A5A5F5C83}"/>
              </c:ext>
            </c:extLst>
          </c:dPt>
          <c:xVal>
            <c:numRef>
              <c:f>'Rash(220311)'!$E$2:$E$30</c:f>
              <c:numCache>
                <c:formatCode>General</c:formatCode>
                <c:ptCount val="29"/>
                <c:pt idx="0">
                  <c:v>0.6</c:v>
                </c:pt>
                <c:pt idx="1">
                  <c:v>0.4</c:v>
                </c:pt>
                <c:pt idx="2">
                  <c:v>0.3</c:v>
                </c:pt>
                <c:pt idx="3">
                  <c:v>0.5</c:v>
                </c:pt>
                <c:pt idx="4">
                  <c:v>0.5</c:v>
                </c:pt>
                <c:pt idx="5">
                  <c:v>0.4</c:v>
                </c:pt>
                <c:pt idx="6">
                  <c:v>0.6</c:v>
                </c:pt>
                <c:pt idx="7">
                  <c:v>0.5</c:v>
                </c:pt>
                <c:pt idx="8">
                  <c:v>0.5</c:v>
                </c:pt>
                <c:pt idx="9">
                  <c:v>0.7</c:v>
                </c:pt>
                <c:pt idx="10">
                  <c:v>0.5</c:v>
                </c:pt>
                <c:pt idx="11">
                  <c:v>0.45</c:v>
                </c:pt>
                <c:pt idx="12">
                  <c:v>0.55000000000000004</c:v>
                </c:pt>
                <c:pt idx="13">
                  <c:v>1.5</c:v>
                </c:pt>
                <c:pt idx="14">
                  <c:v>1.5</c:v>
                </c:pt>
                <c:pt idx="15">
                  <c:v>1.45</c:v>
                </c:pt>
                <c:pt idx="16">
                  <c:v>1.55</c:v>
                </c:pt>
                <c:pt idx="17">
                  <c:v>1.5</c:v>
                </c:pt>
                <c:pt idx="18">
                  <c:v>0.5</c:v>
                </c:pt>
                <c:pt idx="19">
                  <c:v>1.5</c:v>
                </c:pt>
              </c:numCache>
            </c:numRef>
          </c:xVal>
          <c:yVal>
            <c:numRef>
              <c:f>'Rash(220311)'!$F$2:$F$30</c:f>
              <c:numCache>
                <c:formatCode>General</c:formatCode>
                <c:ptCount val="29"/>
                <c:pt idx="0">
                  <c:v>6.1482070000000002</c:v>
                </c:pt>
                <c:pt idx="1">
                  <c:v>5.9167594000000001</c:v>
                </c:pt>
                <c:pt idx="2">
                  <c:v>6.5676436000000002</c:v>
                </c:pt>
                <c:pt idx="3">
                  <c:v>8.6831391999999994</c:v>
                </c:pt>
                <c:pt idx="4">
                  <c:v>4.8929938999999996</c:v>
                </c:pt>
                <c:pt idx="5">
                  <c:v>14.278466999999999</c:v>
                </c:pt>
                <c:pt idx="6">
                  <c:v>14.598188</c:v>
                </c:pt>
                <c:pt idx="7">
                  <c:v>15.342646999999999</c:v>
                </c:pt>
                <c:pt idx="8">
                  <c:v>6.8755667000000003</c:v>
                </c:pt>
                <c:pt idx="9">
                  <c:v>6.4035595000000001</c:v>
                </c:pt>
                <c:pt idx="10">
                  <c:v>10.621884</c:v>
                </c:pt>
                <c:pt idx="11">
                  <c:v>12.06644</c:v>
                </c:pt>
                <c:pt idx="12">
                  <c:v>12.377668999999999</c:v>
                </c:pt>
                <c:pt idx="13">
                  <c:v>5.1046490999999996</c:v>
                </c:pt>
                <c:pt idx="14">
                  <c:v>7.5507549999999997</c:v>
                </c:pt>
                <c:pt idx="15">
                  <c:v>10.663679</c:v>
                </c:pt>
                <c:pt idx="16">
                  <c:v>10.508322</c:v>
                </c:pt>
                <c:pt idx="17">
                  <c:v>12.173482</c:v>
                </c:pt>
                <c:pt idx="18">
                  <c:v>9.1999999999999993</c:v>
                </c:pt>
                <c:pt idx="19">
                  <c:v>9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52D9-2343-9E00-856A5A5F5C8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73049904"/>
        <c:axId val="972479648"/>
      </c:scatterChart>
      <c:valAx>
        <c:axId val="973049904"/>
        <c:scaling>
          <c:orientation val="minMax"/>
          <c:max val="2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one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72479648"/>
        <c:crosses val="autoZero"/>
        <c:crossBetween val="midCat"/>
      </c:valAx>
      <c:valAx>
        <c:axId val="972479648"/>
        <c:scaling>
          <c:orientation val="minMax"/>
          <c:max val="2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in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973049904"/>
        <c:crosses val="autoZero"/>
        <c:crossBetween val="midCat"/>
        <c:majorUnit val="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611623-3871-47E7-B7C7-B9DFEAD163BC}" type="datetimeFigureOut">
              <a:rPr kumimoji="1" lang="ja-JP" altLang="en-US" smtClean="0"/>
              <a:t>2022/3/2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3C25BBE-A27D-4741-BC7D-C7CCB961F1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20807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3C25BBE-A27D-4741-BC7D-C7CCB961F141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80316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E1F17-D0A5-485C-9212-37B49F330DCA}" type="datetimeFigureOut">
              <a:rPr kumimoji="1" lang="ja-JP" altLang="en-US" smtClean="0"/>
              <a:t>2022/3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84DED-3BD0-49BC-9B55-2CA05B627F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10239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E1F17-D0A5-485C-9212-37B49F330DCA}" type="datetimeFigureOut">
              <a:rPr kumimoji="1" lang="ja-JP" altLang="en-US" smtClean="0"/>
              <a:t>2022/3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84DED-3BD0-49BC-9B55-2CA05B627F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43033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E1F17-D0A5-485C-9212-37B49F330DCA}" type="datetimeFigureOut">
              <a:rPr kumimoji="1" lang="ja-JP" altLang="en-US" smtClean="0"/>
              <a:t>2022/3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84DED-3BD0-49BC-9B55-2CA05B627F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11514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E1F17-D0A5-485C-9212-37B49F330DCA}" type="datetimeFigureOut">
              <a:rPr kumimoji="1" lang="ja-JP" altLang="en-US" smtClean="0"/>
              <a:t>2022/3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84DED-3BD0-49BC-9B55-2CA05B627F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57515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E1F17-D0A5-485C-9212-37B49F330DCA}" type="datetimeFigureOut">
              <a:rPr kumimoji="1" lang="ja-JP" altLang="en-US" smtClean="0"/>
              <a:t>2022/3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84DED-3BD0-49BC-9B55-2CA05B627F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79935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E1F17-D0A5-485C-9212-37B49F330DCA}" type="datetimeFigureOut">
              <a:rPr kumimoji="1" lang="ja-JP" altLang="en-US" smtClean="0"/>
              <a:t>2022/3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84DED-3BD0-49BC-9B55-2CA05B627F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98521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E1F17-D0A5-485C-9212-37B49F330DCA}" type="datetimeFigureOut">
              <a:rPr kumimoji="1" lang="ja-JP" altLang="en-US" smtClean="0"/>
              <a:t>2022/3/2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84DED-3BD0-49BC-9B55-2CA05B627F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96064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E1F17-D0A5-485C-9212-37B49F330DCA}" type="datetimeFigureOut">
              <a:rPr kumimoji="1" lang="ja-JP" altLang="en-US" smtClean="0"/>
              <a:t>2022/3/2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84DED-3BD0-49BC-9B55-2CA05B627F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54954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E1F17-D0A5-485C-9212-37B49F330DCA}" type="datetimeFigureOut">
              <a:rPr kumimoji="1" lang="ja-JP" altLang="en-US" smtClean="0"/>
              <a:t>2022/3/2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84DED-3BD0-49BC-9B55-2CA05B627F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59921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E1F17-D0A5-485C-9212-37B49F330DCA}" type="datetimeFigureOut">
              <a:rPr kumimoji="1" lang="ja-JP" altLang="en-US" smtClean="0"/>
              <a:t>2022/3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84DED-3BD0-49BC-9B55-2CA05B627F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80525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E1F17-D0A5-485C-9212-37B49F330DCA}" type="datetimeFigureOut">
              <a:rPr kumimoji="1" lang="ja-JP" altLang="en-US" smtClean="0"/>
              <a:t>2022/3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84DED-3BD0-49BC-9B55-2CA05B627F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7702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6E1F17-D0A5-485C-9212-37B49F330DCA}" type="datetimeFigureOut">
              <a:rPr kumimoji="1" lang="ja-JP" altLang="en-US" smtClean="0"/>
              <a:t>2022/3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E84DED-3BD0-49BC-9B55-2CA05B627F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97261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10" Type="http://schemas.openxmlformats.org/officeDocument/2006/relationships/chart" Target="../charts/chart8.xml"/><Relationship Id="rId4" Type="http://schemas.openxmlformats.org/officeDocument/2006/relationships/chart" Target="../charts/chart2.xml"/><Relationship Id="rId9" Type="http://schemas.openxmlformats.org/officeDocument/2006/relationships/chart" Target="../charts/char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9" name="グラフ 88">
            <a:extLst>
              <a:ext uri="{FF2B5EF4-FFF2-40B4-BE49-F238E27FC236}">
                <a16:creationId xmlns:a16="http://schemas.microsoft.com/office/drawing/2014/main" id="{DF3540D5-A1E5-D040-8EF6-6776C41FC1F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07296274"/>
              </p:ext>
            </p:extLst>
          </p:nvPr>
        </p:nvGraphicFramePr>
        <p:xfrm>
          <a:off x="4551742" y="3344719"/>
          <a:ext cx="2024435" cy="22395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00" name="グラフ 99">
            <a:extLst>
              <a:ext uri="{FF2B5EF4-FFF2-40B4-BE49-F238E27FC236}">
                <a16:creationId xmlns:a16="http://schemas.microsoft.com/office/drawing/2014/main" id="{7EFA391D-51E6-954B-B994-49283B8FB97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71011696"/>
              </p:ext>
            </p:extLst>
          </p:nvPr>
        </p:nvGraphicFramePr>
        <p:xfrm>
          <a:off x="672151" y="3346865"/>
          <a:ext cx="2015377" cy="22353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02" name="グラフ 101">
            <a:extLst>
              <a:ext uri="{FF2B5EF4-FFF2-40B4-BE49-F238E27FC236}">
                <a16:creationId xmlns:a16="http://schemas.microsoft.com/office/drawing/2014/main" id="{111EE078-7873-7E4C-A8EA-166EBA6E12E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58524993"/>
              </p:ext>
            </p:extLst>
          </p:nvPr>
        </p:nvGraphicFramePr>
        <p:xfrm>
          <a:off x="2609335" y="3320562"/>
          <a:ext cx="2020600" cy="22879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04" name="グラフ 103">
            <a:extLst>
              <a:ext uri="{FF2B5EF4-FFF2-40B4-BE49-F238E27FC236}">
                <a16:creationId xmlns:a16="http://schemas.microsoft.com/office/drawing/2014/main" id="{53CCE00E-6DAB-DC4F-B93B-9EBE329883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54587178"/>
              </p:ext>
            </p:extLst>
          </p:nvPr>
        </p:nvGraphicFramePr>
        <p:xfrm>
          <a:off x="6497985" y="3347894"/>
          <a:ext cx="2019496" cy="22332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88" name="グラフ 87">
            <a:extLst>
              <a:ext uri="{FF2B5EF4-FFF2-40B4-BE49-F238E27FC236}">
                <a16:creationId xmlns:a16="http://schemas.microsoft.com/office/drawing/2014/main" id="{EF5C50AB-B2A0-854C-81E0-F7E58A54289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90616309"/>
              </p:ext>
            </p:extLst>
          </p:nvPr>
        </p:nvGraphicFramePr>
        <p:xfrm>
          <a:off x="4538102" y="953359"/>
          <a:ext cx="2044896" cy="22332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99" name="グラフ 98">
            <a:extLst>
              <a:ext uri="{FF2B5EF4-FFF2-40B4-BE49-F238E27FC236}">
                <a16:creationId xmlns:a16="http://schemas.microsoft.com/office/drawing/2014/main" id="{B358F3E4-650C-C747-A4A2-02857FFD470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1966196"/>
              </p:ext>
            </p:extLst>
          </p:nvPr>
        </p:nvGraphicFramePr>
        <p:xfrm>
          <a:off x="668032" y="953359"/>
          <a:ext cx="2019496" cy="22332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03" name="グラフ 102">
            <a:extLst>
              <a:ext uri="{FF2B5EF4-FFF2-40B4-BE49-F238E27FC236}">
                <a16:creationId xmlns:a16="http://schemas.microsoft.com/office/drawing/2014/main" id="{D4159E0B-FAC6-774E-B941-2A0A48C3F33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52608222"/>
              </p:ext>
            </p:extLst>
          </p:nvPr>
        </p:nvGraphicFramePr>
        <p:xfrm>
          <a:off x="6497985" y="953359"/>
          <a:ext cx="2019496" cy="22332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7CACF967-B992-4380-B934-16E3BC8F07DE}"/>
              </a:ext>
            </a:extLst>
          </p:cNvPr>
          <p:cNvSpPr txBox="1"/>
          <p:nvPr/>
        </p:nvSpPr>
        <p:spPr>
          <a:xfrm>
            <a:off x="148134" y="774366"/>
            <a:ext cx="461665" cy="2654633"/>
          </a:xfrm>
          <a:prstGeom prst="rect">
            <a:avLst/>
          </a:prstGeom>
          <a:noFill/>
        </p:spPr>
        <p:txBody>
          <a:bodyPr vert="vert270" wrap="square" rtlCol="0" anchor="ctr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Gefitinib AUC</a:t>
            </a:r>
            <a:r>
              <a:rPr kumimoji="1" lang="en-US" altLang="ja-JP" baseline="-25000" dirty="0">
                <a:latin typeface="Arial" panose="020B0604020202020204" pitchFamily="34" charset="0"/>
                <a:cs typeface="Arial" panose="020B0604020202020204" pitchFamily="34" charset="0"/>
              </a:rPr>
              <a:t>0−48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µM</a:t>
            </a:r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･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h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0BFDB074-55F1-4436-AC46-A9668528C63B}"/>
              </a:ext>
            </a:extLst>
          </p:cNvPr>
          <p:cNvSpPr txBox="1"/>
          <p:nvPr/>
        </p:nvSpPr>
        <p:spPr>
          <a:xfrm>
            <a:off x="-17477" y="-23505"/>
            <a:ext cx="3352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Nio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et al. Supplementary Fig. 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F607BB20-2BB3-4679-95EC-BE064488CEF6}"/>
              </a:ext>
            </a:extLst>
          </p:cNvPr>
          <p:cNvSpPr txBox="1"/>
          <p:nvPr/>
        </p:nvSpPr>
        <p:spPr>
          <a:xfrm>
            <a:off x="9634" y="3542352"/>
            <a:ext cx="738664" cy="2479520"/>
          </a:xfrm>
          <a:prstGeom prst="rect">
            <a:avLst/>
          </a:prstGeom>
          <a:noFill/>
        </p:spPr>
        <p:txBody>
          <a:bodyPr vert="vert270" wrap="square" rtlCol="0" anchor="ctr">
            <a:spAutoFit/>
          </a:bodyPr>
          <a:lstStyle/>
          <a:p>
            <a:pPr algn="ctr"/>
            <a:r>
              <a:rPr kumimoji="1" lang="en-US" altLang="ja-JP" i="1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desmethyl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gefitinib AUC</a:t>
            </a:r>
            <a:r>
              <a:rPr kumimoji="1" lang="en-US" altLang="ja-JP" baseline="-25000" dirty="0">
                <a:latin typeface="Arial" panose="020B0604020202020204" pitchFamily="34" charset="0"/>
                <a:cs typeface="Arial" panose="020B0604020202020204" pitchFamily="34" charset="0"/>
              </a:rPr>
              <a:t>0−48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kumimoji="1"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･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h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78427346-6074-428A-BAE3-A1A9A9270168}"/>
              </a:ext>
            </a:extLst>
          </p:cNvPr>
          <p:cNvSpPr txBox="1"/>
          <p:nvPr/>
        </p:nvSpPr>
        <p:spPr>
          <a:xfrm>
            <a:off x="3216106" y="5785725"/>
            <a:ext cx="10932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ash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3E534C6D-E27C-4C5B-B03A-45628BD9663C}"/>
              </a:ext>
            </a:extLst>
          </p:cNvPr>
          <p:cNvSpPr txBox="1"/>
          <p:nvPr/>
        </p:nvSpPr>
        <p:spPr>
          <a:xfrm>
            <a:off x="1514930" y="864162"/>
            <a:ext cx="10502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=0.566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9D3BD2DB-9395-4ACF-AB8A-F9A8FCD42E2A}"/>
              </a:ext>
            </a:extLst>
          </p:cNvPr>
          <p:cNvSpPr txBox="1"/>
          <p:nvPr/>
        </p:nvSpPr>
        <p:spPr>
          <a:xfrm>
            <a:off x="5075103" y="5785725"/>
            <a:ext cx="13877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norexia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582C009D-F59B-4AA2-8DB3-848359B77EBB}"/>
              </a:ext>
            </a:extLst>
          </p:cNvPr>
          <p:cNvSpPr txBox="1"/>
          <p:nvPr/>
        </p:nvSpPr>
        <p:spPr>
          <a:xfrm>
            <a:off x="1206603" y="864162"/>
            <a:ext cx="52012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ja-JP" altLang="en-US" dirty="0"/>
          </a:p>
        </p:txBody>
      </p:sp>
      <p:cxnSp>
        <p:nvCxnSpPr>
          <p:cNvPr id="85" name="直線コネクタ 84">
            <a:extLst>
              <a:ext uri="{FF2B5EF4-FFF2-40B4-BE49-F238E27FC236}">
                <a16:creationId xmlns:a16="http://schemas.microsoft.com/office/drawing/2014/main" id="{0E529197-5B4D-6741-BE16-70E11EF76C4F}"/>
              </a:ext>
            </a:extLst>
          </p:cNvPr>
          <p:cNvCxnSpPr>
            <a:cxnSpLocks/>
          </p:cNvCxnSpPr>
          <p:nvPr/>
        </p:nvCxnSpPr>
        <p:spPr>
          <a:xfrm>
            <a:off x="5428155" y="2925679"/>
            <a:ext cx="0" cy="7200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直線コネクタ 85">
            <a:extLst>
              <a:ext uri="{FF2B5EF4-FFF2-40B4-BE49-F238E27FC236}">
                <a16:creationId xmlns:a16="http://schemas.microsoft.com/office/drawing/2014/main" id="{5499BC60-5739-D244-8E2C-E7B24171576A}"/>
              </a:ext>
            </a:extLst>
          </p:cNvPr>
          <p:cNvCxnSpPr>
            <a:cxnSpLocks/>
          </p:cNvCxnSpPr>
          <p:nvPr/>
        </p:nvCxnSpPr>
        <p:spPr>
          <a:xfrm>
            <a:off x="6098938" y="2925679"/>
            <a:ext cx="0" cy="7200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F17F9073-95C8-6E4E-B272-7CAF1E664FF3}"/>
              </a:ext>
            </a:extLst>
          </p:cNvPr>
          <p:cNvSpPr txBox="1"/>
          <p:nvPr/>
        </p:nvSpPr>
        <p:spPr>
          <a:xfrm>
            <a:off x="7228594" y="5785725"/>
            <a:ext cx="10932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atigue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2D13DE5F-6F06-7A49-A37F-AEFD86C9A0AB}"/>
              </a:ext>
            </a:extLst>
          </p:cNvPr>
          <p:cNvSpPr txBox="1"/>
          <p:nvPr/>
        </p:nvSpPr>
        <p:spPr>
          <a:xfrm>
            <a:off x="1357109" y="5785725"/>
            <a:ext cx="10932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Diarrhea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13B4A83C-1596-F745-804A-67E86901ABE2}"/>
              </a:ext>
            </a:extLst>
          </p:cNvPr>
          <p:cNvGrpSpPr/>
          <p:nvPr/>
        </p:nvGrpSpPr>
        <p:grpSpPr>
          <a:xfrm>
            <a:off x="1042945" y="5417868"/>
            <a:ext cx="1664692" cy="369332"/>
            <a:chOff x="1027447" y="5462081"/>
            <a:chExt cx="1664692" cy="369332"/>
          </a:xfrm>
        </p:grpSpPr>
        <p:sp>
          <p:nvSpPr>
            <p:cNvPr id="97" name="テキスト ボックス 96">
              <a:extLst>
                <a:ext uri="{FF2B5EF4-FFF2-40B4-BE49-F238E27FC236}">
                  <a16:creationId xmlns:a16="http://schemas.microsoft.com/office/drawing/2014/main" id="{D4BF547B-F58E-674A-A436-BA64B41B2C50}"/>
                </a:ext>
              </a:extLst>
            </p:cNvPr>
            <p:cNvSpPr txBox="1"/>
            <p:nvPr/>
          </p:nvSpPr>
          <p:spPr>
            <a:xfrm>
              <a:off x="1027447" y="5462081"/>
              <a:ext cx="1018228" cy="369332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Grade 0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テキスト ボックス 97">
              <a:extLst>
                <a:ext uri="{FF2B5EF4-FFF2-40B4-BE49-F238E27FC236}">
                  <a16:creationId xmlns:a16="http://schemas.microsoft.com/office/drawing/2014/main" id="{8C133470-6B66-994D-80F4-C54E4D680E48}"/>
                </a:ext>
              </a:extLst>
            </p:cNvPr>
            <p:cNvSpPr txBox="1"/>
            <p:nvPr/>
          </p:nvSpPr>
          <p:spPr>
            <a:xfrm>
              <a:off x="2045808" y="5462081"/>
              <a:ext cx="646331" cy="369332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Any 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9B7E8ED1-F2B0-504E-9FA8-2AF75AE6A373}"/>
              </a:ext>
            </a:extLst>
          </p:cNvPr>
          <p:cNvGrpSpPr/>
          <p:nvPr/>
        </p:nvGrpSpPr>
        <p:grpSpPr>
          <a:xfrm>
            <a:off x="1519373" y="2920140"/>
            <a:ext cx="670783" cy="72000"/>
            <a:chOff x="1623705" y="3111331"/>
            <a:chExt cx="670783" cy="72000"/>
          </a:xfrm>
        </p:grpSpPr>
        <p:cxnSp>
          <p:nvCxnSpPr>
            <p:cNvPr id="107" name="直線コネクタ 106">
              <a:extLst>
                <a:ext uri="{FF2B5EF4-FFF2-40B4-BE49-F238E27FC236}">
                  <a16:creationId xmlns:a16="http://schemas.microsoft.com/office/drawing/2014/main" id="{B3BA6EA9-18AF-B44F-BDED-222C5190C857}"/>
                </a:ext>
              </a:extLst>
            </p:cNvPr>
            <p:cNvCxnSpPr>
              <a:cxnSpLocks/>
            </p:cNvCxnSpPr>
            <p:nvPr/>
          </p:nvCxnSpPr>
          <p:spPr>
            <a:xfrm>
              <a:off x="1623705" y="3111331"/>
              <a:ext cx="0" cy="7200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直線コネクタ 107">
              <a:extLst>
                <a:ext uri="{FF2B5EF4-FFF2-40B4-BE49-F238E27FC236}">
                  <a16:creationId xmlns:a16="http://schemas.microsoft.com/office/drawing/2014/main" id="{BB8E6580-F44B-F14D-842F-683B2A11931A}"/>
                </a:ext>
              </a:extLst>
            </p:cNvPr>
            <p:cNvCxnSpPr>
              <a:cxnSpLocks/>
            </p:cNvCxnSpPr>
            <p:nvPr/>
          </p:nvCxnSpPr>
          <p:spPr>
            <a:xfrm>
              <a:off x="2294488" y="3111331"/>
              <a:ext cx="0" cy="7200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9" name="グループ化 108">
            <a:extLst>
              <a:ext uri="{FF2B5EF4-FFF2-40B4-BE49-F238E27FC236}">
                <a16:creationId xmlns:a16="http://schemas.microsoft.com/office/drawing/2014/main" id="{294A8FB0-59E2-1C44-8810-A36B967A435A}"/>
              </a:ext>
            </a:extLst>
          </p:cNvPr>
          <p:cNvGrpSpPr/>
          <p:nvPr/>
        </p:nvGrpSpPr>
        <p:grpSpPr>
          <a:xfrm>
            <a:off x="3471485" y="2956513"/>
            <a:ext cx="670783" cy="72000"/>
            <a:chOff x="1623705" y="3111331"/>
            <a:chExt cx="670783" cy="72000"/>
          </a:xfrm>
        </p:grpSpPr>
        <p:cxnSp>
          <p:nvCxnSpPr>
            <p:cNvPr id="110" name="直線コネクタ 109">
              <a:extLst>
                <a:ext uri="{FF2B5EF4-FFF2-40B4-BE49-F238E27FC236}">
                  <a16:creationId xmlns:a16="http://schemas.microsoft.com/office/drawing/2014/main" id="{0EA63B1B-84B6-444D-A807-F15BF2A054A7}"/>
                </a:ext>
              </a:extLst>
            </p:cNvPr>
            <p:cNvCxnSpPr>
              <a:cxnSpLocks/>
            </p:cNvCxnSpPr>
            <p:nvPr/>
          </p:nvCxnSpPr>
          <p:spPr>
            <a:xfrm>
              <a:off x="1623705" y="3111331"/>
              <a:ext cx="0" cy="7200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直線コネクタ 110">
              <a:extLst>
                <a:ext uri="{FF2B5EF4-FFF2-40B4-BE49-F238E27FC236}">
                  <a16:creationId xmlns:a16="http://schemas.microsoft.com/office/drawing/2014/main" id="{FB98C501-3FB4-974E-9FF9-6F0D70DC5D6F}"/>
                </a:ext>
              </a:extLst>
            </p:cNvPr>
            <p:cNvCxnSpPr>
              <a:cxnSpLocks/>
            </p:cNvCxnSpPr>
            <p:nvPr/>
          </p:nvCxnSpPr>
          <p:spPr>
            <a:xfrm>
              <a:off x="2294488" y="3111331"/>
              <a:ext cx="0" cy="7200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2" name="グループ化 111">
            <a:extLst>
              <a:ext uri="{FF2B5EF4-FFF2-40B4-BE49-F238E27FC236}">
                <a16:creationId xmlns:a16="http://schemas.microsoft.com/office/drawing/2014/main" id="{B82E4C5D-B571-634A-8C7E-D6F2C114B380}"/>
              </a:ext>
            </a:extLst>
          </p:cNvPr>
          <p:cNvGrpSpPr/>
          <p:nvPr/>
        </p:nvGrpSpPr>
        <p:grpSpPr>
          <a:xfrm>
            <a:off x="7378444" y="2926684"/>
            <a:ext cx="670783" cy="72000"/>
            <a:chOff x="1623705" y="3111331"/>
            <a:chExt cx="670783" cy="72000"/>
          </a:xfrm>
        </p:grpSpPr>
        <p:cxnSp>
          <p:nvCxnSpPr>
            <p:cNvPr id="113" name="直線コネクタ 112">
              <a:extLst>
                <a:ext uri="{FF2B5EF4-FFF2-40B4-BE49-F238E27FC236}">
                  <a16:creationId xmlns:a16="http://schemas.microsoft.com/office/drawing/2014/main" id="{DA29725E-48CA-534F-B047-038BE0CAAC47}"/>
                </a:ext>
              </a:extLst>
            </p:cNvPr>
            <p:cNvCxnSpPr>
              <a:cxnSpLocks/>
            </p:cNvCxnSpPr>
            <p:nvPr/>
          </p:nvCxnSpPr>
          <p:spPr>
            <a:xfrm>
              <a:off x="1623705" y="3111331"/>
              <a:ext cx="0" cy="7200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直線コネクタ 113">
              <a:extLst>
                <a:ext uri="{FF2B5EF4-FFF2-40B4-BE49-F238E27FC236}">
                  <a16:creationId xmlns:a16="http://schemas.microsoft.com/office/drawing/2014/main" id="{EE0A367E-01FE-CD44-851E-5A64A38DAEE4}"/>
                </a:ext>
              </a:extLst>
            </p:cNvPr>
            <p:cNvCxnSpPr>
              <a:cxnSpLocks/>
            </p:cNvCxnSpPr>
            <p:nvPr/>
          </p:nvCxnSpPr>
          <p:spPr>
            <a:xfrm>
              <a:off x="2294488" y="3111331"/>
              <a:ext cx="0" cy="7200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5" name="グループ化 114">
            <a:extLst>
              <a:ext uri="{FF2B5EF4-FFF2-40B4-BE49-F238E27FC236}">
                <a16:creationId xmlns:a16="http://schemas.microsoft.com/office/drawing/2014/main" id="{01B284AB-2ECC-4343-837A-DB0E70EB186C}"/>
              </a:ext>
            </a:extLst>
          </p:cNvPr>
          <p:cNvGrpSpPr/>
          <p:nvPr/>
        </p:nvGrpSpPr>
        <p:grpSpPr>
          <a:xfrm>
            <a:off x="1539883" y="5322633"/>
            <a:ext cx="670783" cy="72000"/>
            <a:chOff x="1623705" y="3111331"/>
            <a:chExt cx="670783" cy="72000"/>
          </a:xfrm>
        </p:grpSpPr>
        <p:cxnSp>
          <p:nvCxnSpPr>
            <p:cNvPr id="116" name="直線コネクタ 115">
              <a:extLst>
                <a:ext uri="{FF2B5EF4-FFF2-40B4-BE49-F238E27FC236}">
                  <a16:creationId xmlns:a16="http://schemas.microsoft.com/office/drawing/2014/main" id="{9A3E43ED-C350-874D-807D-2CBFC1CB4AA4}"/>
                </a:ext>
              </a:extLst>
            </p:cNvPr>
            <p:cNvCxnSpPr>
              <a:cxnSpLocks/>
            </p:cNvCxnSpPr>
            <p:nvPr/>
          </p:nvCxnSpPr>
          <p:spPr>
            <a:xfrm>
              <a:off x="1623705" y="3111331"/>
              <a:ext cx="0" cy="7200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直線コネクタ 116">
              <a:extLst>
                <a:ext uri="{FF2B5EF4-FFF2-40B4-BE49-F238E27FC236}">
                  <a16:creationId xmlns:a16="http://schemas.microsoft.com/office/drawing/2014/main" id="{5844B2D2-83C4-D643-BB0A-C74A91E82ACC}"/>
                </a:ext>
              </a:extLst>
            </p:cNvPr>
            <p:cNvCxnSpPr>
              <a:cxnSpLocks/>
            </p:cNvCxnSpPr>
            <p:nvPr/>
          </p:nvCxnSpPr>
          <p:spPr>
            <a:xfrm>
              <a:off x="2294488" y="3111331"/>
              <a:ext cx="0" cy="7200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8" name="グループ化 117">
            <a:extLst>
              <a:ext uri="{FF2B5EF4-FFF2-40B4-BE49-F238E27FC236}">
                <a16:creationId xmlns:a16="http://schemas.microsoft.com/office/drawing/2014/main" id="{70A0E818-E8DE-7240-B51E-173FBC420D27}"/>
              </a:ext>
            </a:extLst>
          </p:cNvPr>
          <p:cNvGrpSpPr/>
          <p:nvPr/>
        </p:nvGrpSpPr>
        <p:grpSpPr>
          <a:xfrm>
            <a:off x="3484024" y="5357339"/>
            <a:ext cx="670783" cy="72000"/>
            <a:chOff x="1623705" y="3111331"/>
            <a:chExt cx="670783" cy="72000"/>
          </a:xfrm>
        </p:grpSpPr>
        <p:cxnSp>
          <p:nvCxnSpPr>
            <p:cNvPr id="119" name="直線コネクタ 118">
              <a:extLst>
                <a:ext uri="{FF2B5EF4-FFF2-40B4-BE49-F238E27FC236}">
                  <a16:creationId xmlns:a16="http://schemas.microsoft.com/office/drawing/2014/main" id="{F3627FF1-8042-424A-A854-A951DA2C111E}"/>
                </a:ext>
              </a:extLst>
            </p:cNvPr>
            <p:cNvCxnSpPr>
              <a:cxnSpLocks/>
            </p:cNvCxnSpPr>
            <p:nvPr/>
          </p:nvCxnSpPr>
          <p:spPr>
            <a:xfrm>
              <a:off x="1623705" y="3111331"/>
              <a:ext cx="0" cy="7200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直線コネクタ 119">
              <a:extLst>
                <a:ext uri="{FF2B5EF4-FFF2-40B4-BE49-F238E27FC236}">
                  <a16:creationId xmlns:a16="http://schemas.microsoft.com/office/drawing/2014/main" id="{1D5DCAF1-02E6-1E41-A1D0-BE12C7033BC5}"/>
                </a:ext>
              </a:extLst>
            </p:cNvPr>
            <p:cNvCxnSpPr>
              <a:cxnSpLocks/>
            </p:cNvCxnSpPr>
            <p:nvPr/>
          </p:nvCxnSpPr>
          <p:spPr>
            <a:xfrm>
              <a:off x="2294488" y="3111331"/>
              <a:ext cx="0" cy="7200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1" name="グループ化 120">
            <a:extLst>
              <a:ext uri="{FF2B5EF4-FFF2-40B4-BE49-F238E27FC236}">
                <a16:creationId xmlns:a16="http://schemas.microsoft.com/office/drawing/2014/main" id="{3CABF584-CC83-ED46-8649-4735CCD03254}"/>
              </a:ext>
            </a:extLst>
          </p:cNvPr>
          <p:cNvGrpSpPr/>
          <p:nvPr/>
        </p:nvGrpSpPr>
        <p:grpSpPr>
          <a:xfrm>
            <a:off x="5420685" y="5334371"/>
            <a:ext cx="670783" cy="72000"/>
            <a:chOff x="1623705" y="3111331"/>
            <a:chExt cx="670783" cy="72000"/>
          </a:xfrm>
        </p:grpSpPr>
        <p:cxnSp>
          <p:nvCxnSpPr>
            <p:cNvPr id="122" name="直線コネクタ 121">
              <a:extLst>
                <a:ext uri="{FF2B5EF4-FFF2-40B4-BE49-F238E27FC236}">
                  <a16:creationId xmlns:a16="http://schemas.microsoft.com/office/drawing/2014/main" id="{5C47F38F-C0D0-F946-B044-2CA28CB18C49}"/>
                </a:ext>
              </a:extLst>
            </p:cNvPr>
            <p:cNvCxnSpPr>
              <a:cxnSpLocks/>
            </p:cNvCxnSpPr>
            <p:nvPr/>
          </p:nvCxnSpPr>
          <p:spPr>
            <a:xfrm>
              <a:off x="1623705" y="3111331"/>
              <a:ext cx="0" cy="7200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直線コネクタ 122">
              <a:extLst>
                <a:ext uri="{FF2B5EF4-FFF2-40B4-BE49-F238E27FC236}">
                  <a16:creationId xmlns:a16="http://schemas.microsoft.com/office/drawing/2014/main" id="{D8921599-C532-1943-AEB2-7A550F48CB36}"/>
                </a:ext>
              </a:extLst>
            </p:cNvPr>
            <p:cNvCxnSpPr>
              <a:cxnSpLocks/>
            </p:cNvCxnSpPr>
            <p:nvPr/>
          </p:nvCxnSpPr>
          <p:spPr>
            <a:xfrm>
              <a:off x="2294488" y="3111331"/>
              <a:ext cx="0" cy="7200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4" name="グループ化 123">
            <a:extLst>
              <a:ext uri="{FF2B5EF4-FFF2-40B4-BE49-F238E27FC236}">
                <a16:creationId xmlns:a16="http://schemas.microsoft.com/office/drawing/2014/main" id="{6F95BCC5-741A-B740-9317-6A2EC8FBCB43}"/>
              </a:ext>
            </a:extLst>
          </p:cNvPr>
          <p:cNvGrpSpPr/>
          <p:nvPr/>
        </p:nvGrpSpPr>
        <p:grpSpPr>
          <a:xfrm>
            <a:off x="7377517" y="5328646"/>
            <a:ext cx="670783" cy="72000"/>
            <a:chOff x="1623705" y="3111331"/>
            <a:chExt cx="670783" cy="72000"/>
          </a:xfrm>
        </p:grpSpPr>
        <p:cxnSp>
          <p:nvCxnSpPr>
            <p:cNvPr id="125" name="直線コネクタ 124">
              <a:extLst>
                <a:ext uri="{FF2B5EF4-FFF2-40B4-BE49-F238E27FC236}">
                  <a16:creationId xmlns:a16="http://schemas.microsoft.com/office/drawing/2014/main" id="{C08A33EF-55CB-9040-9CD8-E1123E2C8F95}"/>
                </a:ext>
              </a:extLst>
            </p:cNvPr>
            <p:cNvCxnSpPr>
              <a:cxnSpLocks/>
            </p:cNvCxnSpPr>
            <p:nvPr/>
          </p:nvCxnSpPr>
          <p:spPr>
            <a:xfrm>
              <a:off x="1623705" y="3111331"/>
              <a:ext cx="0" cy="7200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6" name="直線コネクタ 125">
              <a:extLst>
                <a:ext uri="{FF2B5EF4-FFF2-40B4-BE49-F238E27FC236}">
                  <a16:creationId xmlns:a16="http://schemas.microsoft.com/office/drawing/2014/main" id="{DD7E5132-237D-D541-8FEE-8FAD257D6771}"/>
                </a:ext>
              </a:extLst>
            </p:cNvPr>
            <p:cNvCxnSpPr>
              <a:cxnSpLocks/>
            </p:cNvCxnSpPr>
            <p:nvPr/>
          </p:nvCxnSpPr>
          <p:spPr>
            <a:xfrm>
              <a:off x="2294488" y="3111331"/>
              <a:ext cx="0" cy="7200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7" name="テキスト ボックス 126">
            <a:extLst>
              <a:ext uri="{FF2B5EF4-FFF2-40B4-BE49-F238E27FC236}">
                <a16:creationId xmlns:a16="http://schemas.microsoft.com/office/drawing/2014/main" id="{5734B087-E58A-9141-9A1E-9340850E9724}"/>
              </a:ext>
            </a:extLst>
          </p:cNvPr>
          <p:cNvSpPr txBox="1"/>
          <p:nvPr/>
        </p:nvSpPr>
        <p:spPr>
          <a:xfrm>
            <a:off x="3471485" y="864162"/>
            <a:ext cx="10502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=0.883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id="{3F943AEA-DC3E-EE4B-948C-DCEA334A5571}"/>
              </a:ext>
            </a:extLst>
          </p:cNvPr>
          <p:cNvSpPr txBox="1"/>
          <p:nvPr/>
        </p:nvSpPr>
        <p:spPr>
          <a:xfrm>
            <a:off x="3163158" y="864162"/>
            <a:ext cx="52012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ja-JP" altLang="en-US" dirty="0"/>
          </a:p>
        </p:txBody>
      </p:sp>
      <p:sp>
        <p:nvSpPr>
          <p:cNvPr id="129" name="テキスト ボックス 128">
            <a:extLst>
              <a:ext uri="{FF2B5EF4-FFF2-40B4-BE49-F238E27FC236}">
                <a16:creationId xmlns:a16="http://schemas.microsoft.com/office/drawing/2014/main" id="{E61E743E-C9AA-6643-8D2F-2EE214D912C8}"/>
              </a:ext>
            </a:extLst>
          </p:cNvPr>
          <p:cNvSpPr txBox="1"/>
          <p:nvPr/>
        </p:nvSpPr>
        <p:spPr>
          <a:xfrm>
            <a:off x="5376595" y="864162"/>
            <a:ext cx="10502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=0.915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E87CC47D-D66B-BB46-B3EB-A78091C03620}"/>
              </a:ext>
            </a:extLst>
          </p:cNvPr>
          <p:cNvSpPr txBox="1"/>
          <p:nvPr/>
        </p:nvSpPr>
        <p:spPr>
          <a:xfrm>
            <a:off x="5068268" y="864162"/>
            <a:ext cx="52012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ja-JP" altLang="en-US" dirty="0"/>
          </a:p>
        </p:txBody>
      </p: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F9233257-8DD0-5246-954A-8A9DA64C79A4}"/>
              </a:ext>
            </a:extLst>
          </p:cNvPr>
          <p:cNvSpPr txBox="1"/>
          <p:nvPr/>
        </p:nvSpPr>
        <p:spPr>
          <a:xfrm>
            <a:off x="7321582" y="864162"/>
            <a:ext cx="10502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=0.524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テキスト ボックス 131">
            <a:extLst>
              <a:ext uri="{FF2B5EF4-FFF2-40B4-BE49-F238E27FC236}">
                <a16:creationId xmlns:a16="http://schemas.microsoft.com/office/drawing/2014/main" id="{F4E1E392-95C2-7B43-8792-D8DA65A5E3B8}"/>
              </a:ext>
            </a:extLst>
          </p:cNvPr>
          <p:cNvSpPr txBox="1"/>
          <p:nvPr/>
        </p:nvSpPr>
        <p:spPr>
          <a:xfrm>
            <a:off x="7013255" y="864162"/>
            <a:ext cx="52012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lang="ja-JP" altLang="en-US" dirty="0"/>
          </a:p>
        </p:txBody>
      </p:sp>
      <p:sp>
        <p:nvSpPr>
          <p:cNvPr id="133" name="テキスト ボックス 132">
            <a:extLst>
              <a:ext uri="{FF2B5EF4-FFF2-40B4-BE49-F238E27FC236}">
                <a16:creationId xmlns:a16="http://schemas.microsoft.com/office/drawing/2014/main" id="{D919AF9E-6DEB-F645-82BF-37BDC63FA03B}"/>
              </a:ext>
            </a:extLst>
          </p:cNvPr>
          <p:cNvSpPr txBox="1"/>
          <p:nvPr/>
        </p:nvSpPr>
        <p:spPr>
          <a:xfrm>
            <a:off x="1504788" y="3233512"/>
            <a:ext cx="10502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=0.270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608AD177-24ED-BA43-AA9A-67A3FF159D14}"/>
              </a:ext>
            </a:extLst>
          </p:cNvPr>
          <p:cNvSpPr txBox="1"/>
          <p:nvPr/>
        </p:nvSpPr>
        <p:spPr>
          <a:xfrm>
            <a:off x="1196461" y="3233512"/>
            <a:ext cx="52012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  <a:endParaRPr lang="ja-JP" altLang="en-US" dirty="0"/>
          </a:p>
        </p:txBody>
      </p:sp>
      <p:sp>
        <p:nvSpPr>
          <p:cNvPr id="135" name="テキスト ボックス 134">
            <a:extLst>
              <a:ext uri="{FF2B5EF4-FFF2-40B4-BE49-F238E27FC236}">
                <a16:creationId xmlns:a16="http://schemas.microsoft.com/office/drawing/2014/main" id="{265E66AF-D1F4-A746-A85B-601158B8B441}"/>
              </a:ext>
            </a:extLst>
          </p:cNvPr>
          <p:cNvSpPr txBox="1"/>
          <p:nvPr/>
        </p:nvSpPr>
        <p:spPr>
          <a:xfrm>
            <a:off x="3461343" y="3233512"/>
            <a:ext cx="10502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=0.883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2643EB90-7A9F-4545-97FE-0472D6C88383}"/>
              </a:ext>
            </a:extLst>
          </p:cNvPr>
          <p:cNvSpPr txBox="1"/>
          <p:nvPr/>
        </p:nvSpPr>
        <p:spPr>
          <a:xfrm>
            <a:off x="3153016" y="3233512"/>
            <a:ext cx="52012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f)</a:t>
            </a:r>
            <a:endParaRPr lang="ja-JP" altLang="en-US" dirty="0"/>
          </a:p>
        </p:txBody>
      </p:sp>
      <p:sp>
        <p:nvSpPr>
          <p:cNvPr id="137" name="テキスト ボックス 136">
            <a:extLst>
              <a:ext uri="{FF2B5EF4-FFF2-40B4-BE49-F238E27FC236}">
                <a16:creationId xmlns:a16="http://schemas.microsoft.com/office/drawing/2014/main" id="{13C4DCC8-A258-5447-9724-BB8176F27369}"/>
              </a:ext>
            </a:extLst>
          </p:cNvPr>
          <p:cNvSpPr txBox="1"/>
          <p:nvPr/>
        </p:nvSpPr>
        <p:spPr>
          <a:xfrm>
            <a:off x="5366453" y="3233512"/>
            <a:ext cx="10502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=0.288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テキスト ボックス 137">
            <a:extLst>
              <a:ext uri="{FF2B5EF4-FFF2-40B4-BE49-F238E27FC236}">
                <a16:creationId xmlns:a16="http://schemas.microsoft.com/office/drawing/2014/main" id="{42C56042-2474-BC44-8213-ADABE038F201}"/>
              </a:ext>
            </a:extLst>
          </p:cNvPr>
          <p:cNvSpPr txBox="1"/>
          <p:nvPr/>
        </p:nvSpPr>
        <p:spPr>
          <a:xfrm>
            <a:off x="5058126" y="3233512"/>
            <a:ext cx="52012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g)</a:t>
            </a:r>
            <a:endParaRPr lang="ja-JP" altLang="en-US" dirty="0"/>
          </a:p>
        </p:txBody>
      </p:sp>
      <p:sp>
        <p:nvSpPr>
          <p:cNvPr id="139" name="テキスト ボックス 138">
            <a:extLst>
              <a:ext uri="{FF2B5EF4-FFF2-40B4-BE49-F238E27FC236}">
                <a16:creationId xmlns:a16="http://schemas.microsoft.com/office/drawing/2014/main" id="{E79193B0-F314-2D44-A3C0-5BCAF52D7A17}"/>
              </a:ext>
            </a:extLst>
          </p:cNvPr>
          <p:cNvSpPr txBox="1"/>
          <p:nvPr/>
        </p:nvSpPr>
        <p:spPr>
          <a:xfrm>
            <a:off x="7312636" y="3233512"/>
            <a:ext cx="11785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=0.0893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8319EB2D-C314-9D42-B4CE-EEC67CD3B4FB}"/>
              </a:ext>
            </a:extLst>
          </p:cNvPr>
          <p:cNvSpPr txBox="1"/>
          <p:nvPr/>
        </p:nvSpPr>
        <p:spPr>
          <a:xfrm>
            <a:off x="7003113" y="3233512"/>
            <a:ext cx="52012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h)</a:t>
            </a:r>
            <a:endParaRPr lang="ja-JP" altLang="en-US" dirty="0"/>
          </a:p>
        </p:txBody>
      </p:sp>
      <p:grpSp>
        <p:nvGrpSpPr>
          <p:cNvPr id="147" name="グループ化 146">
            <a:extLst>
              <a:ext uri="{FF2B5EF4-FFF2-40B4-BE49-F238E27FC236}">
                <a16:creationId xmlns:a16="http://schemas.microsoft.com/office/drawing/2014/main" id="{ADD7A95C-C851-9149-BE0D-91BF1E3D42E4}"/>
              </a:ext>
            </a:extLst>
          </p:cNvPr>
          <p:cNvGrpSpPr/>
          <p:nvPr/>
        </p:nvGrpSpPr>
        <p:grpSpPr>
          <a:xfrm>
            <a:off x="2963368" y="5417868"/>
            <a:ext cx="1664692" cy="369332"/>
            <a:chOff x="1027447" y="5462081"/>
            <a:chExt cx="1664692" cy="369332"/>
          </a:xfrm>
        </p:grpSpPr>
        <p:sp>
          <p:nvSpPr>
            <p:cNvPr id="148" name="テキスト ボックス 147">
              <a:extLst>
                <a:ext uri="{FF2B5EF4-FFF2-40B4-BE49-F238E27FC236}">
                  <a16:creationId xmlns:a16="http://schemas.microsoft.com/office/drawing/2014/main" id="{56F93C01-8CB6-C54A-B168-6F2FDB766C30}"/>
                </a:ext>
              </a:extLst>
            </p:cNvPr>
            <p:cNvSpPr txBox="1"/>
            <p:nvPr/>
          </p:nvSpPr>
          <p:spPr>
            <a:xfrm>
              <a:off x="1027447" y="5462081"/>
              <a:ext cx="1018228" cy="369332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Grade 0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テキスト ボックス 148">
              <a:extLst>
                <a:ext uri="{FF2B5EF4-FFF2-40B4-BE49-F238E27FC236}">
                  <a16:creationId xmlns:a16="http://schemas.microsoft.com/office/drawing/2014/main" id="{9B5C2954-A10E-3147-9397-D603F51E1231}"/>
                </a:ext>
              </a:extLst>
            </p:cNvPr>
            <p:cNvSpPr txBox="1"/>
            <p:nvPr/>
          </p:nvSpPr>
          <p:spPr>
            <a:xfrm>
              <a:off x="2045808" y="5462081"/>
              <a:ext cx="646331" cy="369332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Any 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0" name="グループ化 149">
            <a:extLst>
              <a:ext uri="{FF2B5EF4-FFF2-40B4-BE49-F238E27FC236}">
                <a16:creationId xmlns:a16="http://schemas.microsoft.com/office/drawing/2014/main" id="{46177920-B22E-3C40-A56C-AF7DE3FAAE21}"/>
              </a:ext>
            </a:extLst>
          </p:cNvPr>
          <p:cNvGrpSpPr/>
          <p:nvPr/>
        </p:nvGrpSpPr>
        <p:grpSpPr>
          <a:xfrm>
            <a:off x="4927150" y="5417868"/>
            <a:ext cx="1664692" cy="369332"/>
            <a:chOff x="1027447" y="5462081"/>
            <a:chExt cx="1664692" cy="369332"/>
          </a:xfrm>
        </p:grpSpPr>
        <p:sp>
          <p:nvSpPr>
            <p:cNvPr id="151" name="テキスト ボックス 150">
              <a:extLst>
                <a:ext uri="{FF2B5EF4-FFF2-40B4-BE49-F238E27FC236}">
                  <a16:creationId xmlns:a16="http://schemas.microsoft.com/office/drawing/2014/main" id="{F630CEAD-49AD-7340-8D00-5D13B8D9C6E7}"/>
                </a:ext>
              </a:extLst>
            </p:cNvPr>
            <p:cNvSpPr txBox="1"/>
            <p:nvPr/>
          </p:nvSpPr>
          <p:spPr>
            <a:xfrm>
              <a:off x="1027447" y="5462081"/>
              <a:ext cx="1018228" cy="369332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Grade 0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テキスト ボックス 151">
              <a:extLst>
                <a:ext uri="{FF2B5EF4-FFF2-40B4-BE49-F238E27FC236}">
                  <a16:creationId xmlns:a16="http://schemas.microsoft.com/office/drawing/2014/main" id="{8784E12C-B470-124D-ADE1-3FB26473D87D}"/>
                </a:ext>
              </a:extLst>
            </p:cNvPr>
            <p:cNvSpPr txBox="1"/>
            <p:nvPr/>
          </p:nvSpPr>
          <p:spPr>
            <a:xfrm>
              <a:off x="2045808" y="5462081"/>
              <a:ext cx="646331" cy="369332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Any 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3" name="グループ化 152">
            <a:extLst>
              <a:ext uri="{FF2B5EF4-FFF2-40B4-BE49-F238E27FC236}">
                <a16:creationId xmlns:a16="http://schemas.microsoft.com/office/drawing/2014/main" id="{9E96445F-098E-E74B-8FFE-832F4C8ACF04}"/>
              </a:ext>
            </a:extLst>
          </p:cNvPr>
          <p:cNvGrpSpPr/>
          <p:nvPr/>
        </p:nvGrpSpPr>
        <p:grpSpPr>
          <a:xfrm>
            <a:off x="6874207" y="5417868"/>
            <a:ext cx="1664692" cy="369332"/>
            <a:chOff x="1027447" y="5462081"/>
            <a:chExt cx="1664692" cy="369332"/>
          </a:xfrm>
        </p:grpSpPr>
        <p:sp>
          <p:nvSpPr>
            <p:cNvPr id="154" name="テキスト ボックス 153">
              <a:extLst>
                <a:ext uri="{FF2B5EF4-FFF2-40B4-BE49-F238E27FC236}">
                  <a16:creationId xmlns:a16="http://schemas.microsoft.com/office/drawing/2014/main" id="{9A085C74-A660-4B47-A79C-27D3C7DCC7AC}"/>
                </a:ext>
              </a:extLst>
            </p:cNvPr>
            <p:cNvSpPr txBox="1"/>
            <p:nvPr/>
          </p:nvSpPr>
          <p:spPr>
            <a:xfrm>
              <a:off x="1027447" y="5462081"/>
              <a:ext cx="1018228" cy="369332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Grade 0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テキスト ボックス 154">
              <a:extLst>
                <a:ext uri="{FF2B5EF4-FFF2-40B4-BE49-F238E27FC236}">
                  <a16:creationId xmlns:a16="http://schemas.microsoft.com/office/drawing/2014/main" id="{2AC2C7C5-DEBE-C148-8A38-07D64F9F23A1}"/>
                </a:ext>
              </a:extLst>
            </p:cNvPr>
            <p:cNvSpPr txBox="1"/>
            <p:nvPr/>
          </p:nvSpPr>
          <p:spPr>
            <a:xfrm>
              <a:off x="2045808" y="5462081"/>
              <a:ext cx="646331" cy="369332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Any 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69" name="グラフ 68">
            <a:extLst>
              <a:ext uri="{FF2B5EF4-FFF2-40B4-BE49-F238E27FC236}">
                <a16:creationId xmlns:a16="http://schemas.microsoft.com/office/drawing/2014/main" id="{3A46C4B3-80F4-7B4E-A630-AEC8C5BEA81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49487620"/>
              </p:ext>
            </p:extLst>
          </p:nvPr>
        </p:nvGraphicFramePr>
        <p:xfrm>
          <a:off x="2609335" y="921068"/>
          <a:ext cx="2020600" cy="22879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</p:spTree>
    <p:extLst>
      <p:ext uri="{BB962C8B-B14F-4D97-AF65-F5344CB8AC3E}">
        <p14:creationId xmlns:p14="http://schemas.microsoft.com/office/powerpoint/2010/main" val="27800809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92</Words>
  <Application>Microsoft Office PowerPoint</Application>
  <PresentationFormat>画面に合わせる (4:3)</PresentationFormat>
  <Paragraphs>32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ioya</dc:creator>
  <cp:lastModifiedBy>ken-ichi-fujita@nifty.com</cp:lastModifiedBy>
  <cp:revision>31</cp:revision>
  <dcterms:created xsi:type="dcterms:W3CDTF">2021-09-05T10:38:24Z</dcterms:created>
  <dcterms:modified xsi:type="dcterms:W3CDTF">2022-03-25T05:18:37Z</dcterms:modified>
</cp:coreProperties>
</file>